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9" r:id="rId2"/>
    <p:sldId id="268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599"/>
    <p:restoredTop sz="94586"/>
  </p:normalViewPr>
  <p:slideViewPr>
    <p:cSldViewPr snapToGrid="0" snapToObjects="1">
      <p:cViewPr varScale="1">
        <p:scale>
          <a:sx n="60" d="100"/>
          <a:sy n="60" d="100"/>
        </p:scale>
        <p:origin x="312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G:\plosone\manuscript\orthology%20graoph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G:\plosone\manuscript\orthology%20graoph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'air-graph'!$J$2</c:f>
              <c:strCache>
                <c:ptCount val="1"/>
                <c:pt idx="0">
                  <c:v>AB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ir-graph'!$M$3:$M$35</c:f>
                <c:numCache>
                  <c:formatCode>General</c:formatCode>
                  <c:ptCount val="33"/>
                  <c:pt idx="0">
                    <c:v>1.0140369042337496E-3</c:v>
                  </c:pt>
                  <c:pt idx="1">
                    <c:v>1.1910494138174621E-3</c:v>
                  </c:pt>
                  <c:pt idx="2">
                    <c:v>5.6929883507411466E-4</c:v>
                  </c:pt>
                  <c:pt idx="3">
                    <c:v>7.3899872130947812E-4</c:v>
                  </c:pt>
                  <c:pt idx="4">
                    <c:v>7.5068839900072385E-4</c:v>
                  </c:pt>
                  <c:pt idx="5">
                    <c:v>1.2024500025037115E-3</c:v>
                  </c:pt>
                  <c:pt idx="6">
                    <c:v>5.3868636116185544E-4</c:v>
                  </c:pt>
                  <c:pt idx="7">
                    <c:v>6.164073578244565E-4</c:v>
                  </c:pt>
                  <c:pt idx="8">
                    <c:v>4.7762581300556908E-4</c:v>
                  </c:pt>
                  <c:pt idx="9">
                    <c:v>3.6691537811779092E-4</c:v>
                  </c:pt>
                  <c:pt idx="10">
                    <c:v>1.4063291683253287E-4</c:v>
                  </c:pt>
                  <c:pt idx="11">
                    <c:v>3.6170485718637322E-4</c:v>
                  </c:pt>
                  <c:pt idx="12">
                    <c:v>1.22507540056327E-3</c:v>
                  </c:pt>
                  <c:pt idx="13">
                    <c:v>2.9476657948240495E-4</c:v>
                  </c:pt>
                  <c:pt idx="14">
                    <c:v>1.707848687040463E-4</c:v>
                  </c:pt>
                  <c:pt idx="15">
                    <c:v>4.3638859067039217E-4</c:v>
                  </c:pt>
                  <c:pt idx="16">
                    <c:v>2.5395591814158369E-4</c:v>
                  </c:pt>
                  <c:pt idx="17">
                    <c:v>1.348946306826236E-4</c:v>
                  </c:pt>
                  <c:pt idx="18">
                    <c:v>1.6750546133822251E-4</c:v>
                  </c:pt>
                  <c:pt idx="19">
                    <c:v>2.866841538291752E-4</c:v>
                  </c:pt>
                  <c:pt idx="20">
                    <c:v>1.1712862128344488E-4</c:v>
                  </c:pt>
                  <c:pt idx="21">
                    <c:v>1.7129442380649937E-4</c:v>
                  </c:pt>
                  <c:pt idx="22">
                    <c:v>2.7341291044688363E-4</c:v>
                  </c:pt>
                  <c:pt idx="23">
                    <c:v>1.4074595015449247E-4</c:v>
                  </c:pt>
                  <c:pt idx="24">
                    <c:v>4.8724738782584349E-4</c:v>
                  </c:pt>
                  <c:pt idx="25">
                    <c:v>5.0842305369019024E-4</c:v>
                  </c:pt>
                  <c:pt idx="26">
                    <c:v>1.6081229757020275E-4</c:v>
                  </c:pt>
                  <c:pt idx="27">
                    <c:v>1.646759523326059E-4</c:v>
                  </c:pt>
                  <c:pt idx="28">
                    <c:v>4.533547411614619E-4</c:v>
                  </c:pt>
                  <c:pt idx="29">
                    <c:v>2.2086463441106267E-4</c:v>
                  </c:pt>
                  <c:pt idx="30">
                    <c:v>2.7059334199852674E-4</c:v>
                  </c:pt>
                  <c:pt idx="31">
                    <c:v>4.3292388176894051E-4</c:v>
                  </c:pt>
                  <c:pt idx="32">
                    <c:v>5.9383829915641119E-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air-graph'!$I$3:$I$35</c:f>
              <c:strCache>
                <c:ptCount val="33"/>
                <c:pt idx="0">
                  <c:v>K02014; iron complex outermembrane recepter protein</c:v>
                </c:pt>
                <c:pt idx="1">
                  <c:v>K06147; ATP-binding cassette, subfamily B, bacterial</c:v>
                </c:pt>
                <c:pt idx="2">
                  <c:v>K03406; methyl-accepting chemotaxis protein</c:v>
                </c:pt>
                <c:pt idx="3">
                  <c:v>K03296; hydrophobic/amphiphilic exporter-1 (mainly G- bacteria), HAE1 family</c:v>
                </c:pt>
                <c:pt idx="4">
                  <c:v>K02004; putative ABC transport system permease protein</c:v>
                </c:pt>
                <c:pt idx="5">
                  <c:v>K08300; ribonuclease E [EC:3.1.26.12]</c:v>
                </c:pt>
                <c:pt idx="6">
                  <c:v>K07497; putative transposase</c:v>
                </c:pt>
                <c:pt idx="7">
                  <c:v>K00059; 3-oxoacyl-[acyl-carrier protein] reductase [EC:1.1.1.100]</c:v>
                </c:pt>
                <c:pt idx="8">
                  <c:v>K02035; peptide/nickel transport system substrate-binding protein</c:v>
                </c:pt>
                <c:pt idx="9">
                  <c:v>K02519; translation initiation factor IF-2</c:v>
                </c:pt>
                <c:pt idx="10">
                  <c:v>K03701; excinuclease ABC subunit A</c:v>
                </c:pt>
                <c:pt idx="11">
                  <c:v>K00936; [EC:2.7.3.-]</c:v>
                </c:pt>
                <c:pt idx="12">
                  <c:v>K01999; branched-chain amino acid transport system substrate-binding protein</c:v>
                </c:pt>
                <c:pt idx="13">
                  <c:v>K03088; RNA polymerase sigma-70 factor, ECF subfamily</c:v>
                </c:pt>
                <c:pt idx="14">
                  <c:v>K03046; DNA-directed RNA polymerase subunit beta' [EC:2.7.7.6]</c:v>
                </c:pt>
                <c:pt idx="15">
                  <c:v>K03657; DNA helicase II / ATP-dependent DNA helicase PcrA [EC:3.6.4.12]</c:v>
                </c:pt>
                <c:pt idx="16">
                  <c:v>K01955; carbamoyl-phosphate synthase large subunit [EC:6.3.5.5]</c:v>
                </c:pt>
                <c:pt idx="17">
                  <c:v>K03043; DNA-directed RNA polymerase subunit beta [EC:2.7.7.6]</c:v>
                </c:pt>
                <c:pt idx="18">
                  <c:v>K01533; Cu2+-exporting ATPase [EC:3.6.3.4]</c:v>
                </c:pt>
                <c:pt idx="19">
                  <c:v>K03466; DNA segregation ATPase FtsK/SpoIIIE, S-DNA-T family</c:v>
                </c:pt>
                <c:pt idx="20">
                  <c:v>K01952; phosphoribosylformylglycinamidine synthase [EC:6.3.5.3]</c:v>
                </c:pt>
                <c:pt idx="21">
                  <c:v>K02337; DNA polymerase III subunit alpha [EC:2.7.7.7]</c:v>
                </c:pt>
                <c:pt idx="22">
                  <c:v>K00540; [EC:1.-.-.-]</c:v>
                </c:pt>
                <c:pt idx="23">
                  <c:v>K01652; acetolactate synthase I/II/III large subunit [EC:2.2.1.6]</c:v>
                </c:pt>
                <c:pt idx="24">
                  <c:v>K02529; LacI family transcriptional regulator</c:v>
                </c:pt>
                <c:pt idx="25">
                  <c:v>K01190; beta-galactosidase [EC:3.2.1.23]</c:v>
                </c:pt>
                <c:pt idx="26">
                  <c:v>K01153; type I restriction enzyme, R subunit [EC:3.1.21.3]</c:v>
                </c:pt>
                <c:pt idx="27">
                  <c:v>K02355; elongation factor G</c:v>
                </c:pt>
                <c:pt idx="28">
                  <c:v>K02003; putative ABC transport system ATP-binding protein</c:v>
                </c:pt>
                <c:pt idx="29">
                  <c:v>K01915; glutamine synthetase [EC:6.3.1.2]</c:v>
                </c:pt>
                <c:pt idx="30">
                  <c:v>K02469; DNA gyrase subunit A [EC:5.99.1.3]</c:v>
                </c:pt>
                <c:pt idx="31">
                  <c:v>K05349; beta-glucosidase [EC:3.2.1.21]</c:v>
                </c:pt>
                <c:pt idx="32">
                  <c:v>K00257; [EC:1.3.99.-]</c:v>
                </c:pt>
              </c:strCache>
            </c:strRef>
          </c:cat>
          <c:val>
            <c:numRef>
              <c:f>'air-graph'!$J$3:$J$35</c:f>
              <c:numCache>
                <c:formatCode>General</c:formatCode>
                <c:ptCount val="33"/>
                <c:pt idx="0">
                  <c:v>5.9540354349447641E-3</c:v>
                </c:pt>
                <c:pt idx="1">
                  <c:v>4.6069449578464618E-3</c:v>
                </c:pt>
                <c:pt idx="2">
                  <c:v>5.1198222364343925E-3</c:v>
                </c:pt>
                <c:pt idx="3">
                  <c:v>4.5717216576101147E-3</c:v>
                </c:pt>
                <c:pt idx="4">
                  <c:v>3.2304599469556647E-3</c:v>
                </c:pt>
                <c:pt idx="5">
                  <c:v>4.638246899860447E-3</c:v>
                </c:pt>
                <c:pt idx="6">
                  <c:v>3.4148290686729179E-3</c:v>
                </c:pt>
                <c:pt idx="7">
                  <c:v>3.2993611353502308E-3</c:v>
                </c:pt>
                <c:pt idx="8">
                  <c:v>2.9512397623560806E-3</c:v>
                </c:pt>
                <c:pt idx="9">
                  <c:v>3.0025191263698594E-3</c:v>
                </c:pt>
                <c:pt idx="10">
                  <c:v>2.4577053238625198E-3</c:v>
                </c:pt>
                <c:pt idx="11">
                  <c:v>3.0370347587083506E-3</c:v>
                </c:pt>
                <c:pt idx="12">
                  <c:v>3.4747656213573192E-3</c:v>
                </c:pt>
                <c:pt idx="13">
                  <c:v>2.1161755633634606E-3</c:v>
                </c:pt>
                <c:pt idx="14">
                  <c:v>2.1512768042567568E-3</c:v>
                </c:pt>
                <c:pt idx="15">
                  <c:v>2.05316025066177E-3</c:v>
                </c:pt>
                <c:pt idx="16">
                  <c:v>1.831180413221717E-3</c:v>
                </c:pt>
                <c:pt idx="17">
                  <c:v>2.0583549680894589E-3</c:v>
                </c:pt>
                <c:pt idx="18">
                  <c:v>2.3338806197684293E-3</c:v>
                </c:pt>
                <c:pt idx="19">
                  <c:v>1.9883044318341403E-3</c:v>
                </c:pt>
                <c:pt idx="20">
                  <c:v>1.8990064335801535E-3</c:v>
                </c:pt>
                <c:pt idx="21">
                  <c:v>1.8340676278961357E-3</c:v>
                </c:pt>
                <c:pt idx="22">
                  <c:v>2.3807285000048734E-3</c:v>
                </c:pt>
                <c:pt idx="23">
                  <c:v>2.0786674412912685E-3</c:v>
                </c:pt>
                <c:pt idx="24">
                  <c:v>1.7003989003981257E-3</c:v>
                </c:pt>
                <c:pt idx="25">
                  <c:v>6.9122917606044413E-4</c:v>
                </c:pt>
                <c:pt idx="26">
                  <c:v>1.4751272776260043E-3</c:v>
                </c:pt>
                <c:pt idx="27">
                  <c:v>1.5973449379266822E-3</c:v>
                </c:pt>
                <c:pt idx="28">
                  <c:v>1.3555567375599408E-3</c:v>
                </c:pt>
                <c:pt idx="29">
                  <c:v>1.5197724364881687E-3</c:v>
                </c:pt>
                <c:pt idx="30">
                  <c:v>1.5469072568025345E-3</c:v>
                </c:pt>
                <c:pt idx="31">
                  <c:v>9.4938449183809212E-4</c:v>
                </c:pt>
                <c:pt idx="32">
                  <c:v>2.1451403812839907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CB2-4C3F-ACC7-19CC74DF07BC}"/>
            </c:ext>
          </c:extLst>
        </c:ser>
        <c:ser>
          <c:idx val="1"/>
          <c:order val="1"/>
          <c:tx>
            <c:strRef>
              <c:f>'air-graph'!$K$2</c:f>
              <c:strCache>
                <c:ptCount val="1"/>
                <c:pt idx="0">
                  <c:v>AE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ir-graph'!$N$3:$N$35</c:f>
                <c:numCache>
                  <c:formatCode>General</c:formatCode>
                  <c:ptCount val="33"/>
                  <c:pt idx="0">
                    <c:v>2.5217938343302816E-3</c:v>
                  </c:pt>
                  <c:pt idx="1">
                    <c:v>8.4195689007090851E-4</c:v>
                  </c:pt>
                  <c:pt idx="2">
                    <c:v>8.2884410250204398E-4</c:v>
                  </c:pt>
                  <c:pt idx="3">
                    <c:v>1.2786413732651092E-3</c:v>
                  </c:pt>
                  <c:pt idx="4">
                    <c:v>1.6389562100514849E-3</c:v>
                  </c:pt>
                  <c:pt idx="5">
                    <c:v>1.8375535157395611E-3</c:v>
                  </c:pt>
                  <c:pt idx="6">
                    <c:v>5.6408288146908407E-4</c:v>
                  </c:pt>
                  <c:pt idx="7">
                    <c:v>9.6376023455173256E-4</c:v>
                  </c:pt>
                  <c:pt idx="8">
                    <c:v>1.1994534698532224E-3</c:v>
                  </c:pt>
                  <c:pt idx="9">
                    <c:v>3.7683069495822994E-4</c:v>
                  </c:pt>
                  <c:pt idx="10">
                    <c:v>9.3283838174700842E-4</c:v>
                  </c:pt>
                  <c:pt idx="11">
                    <c:v>4.3787953473038477E-4</c:v>
                  </c:pt>
                  <c:pt idx="12">
                    <c:v>1.5368626132497018E-3</c:v>
                  </c:pt>
                  <c:pt idx="13">
                    <c:v>9.1608541636360871E-4</c:v>
                  </c:pt>
                  <c:pt idx="14">
                    <c:v>3.6059496792485718E-4</c:v>
                  </c:pt>
                  <c:pt idx="15">
                    <c:v>3.4487469519540895E-4</c:v>
                  </c:pt>
                  <c:pt idx="16">
                    <c:v>7.8359154036893518E-4</c:v>
                  </c:pt>
                  <c:pt idx="17">
                    <c:v>3.1049390728930538E-4</c:v>
                  </c:pt>
                  <c:pt idx="18">
                    <c:v>2.0159220906196813E-4</c:v>
                  </c:pt>
                  <c:pt idx="19">
                    <c:v>2.6211367537952327E-4</c:v>
                  </c:pt>
                  <c:pt idx="20">
                    <c:v>3.458418081124809E-4</c:v>
                  </c:pt>
                  <c:pt idx="21">
                    <c:v>3.5128475518416514E-4</c:v>
                  </c:pt>
                  <c:pt idx="22">
                    <c:v>4.1778445836137168E-4</c:v>
                  </c:pt>
                  <c:pt idx="23">
                    <c:v>1.3981683106540182E-4</c:v>
                  </c:pt>
                  <c:pt idx="24">
                    <c:v>2.2129055049237826E-4</c:v>
                  </c:pt>
                  <c:pt idx="25">
                    <c:v>2.3530233720407538E-3</c:v>
                  </c:pt>
                  <c:pt idx="26">
                    <c:v>8.9225626147296114E-4</c:v>
                  </c:pt>
                  <c:pt idx="27">
                    <c:v>4.3627448653895561E-4</c:v>
                  </c:pt>
                  <c:pt idx="28">
                    <c:v>7.7775157972526663E-4</c:v>
                  </c:pt>
                  <c:pt idx="29">
                    <c:v>4.3725469061550433E-4</c:v>
                  </c:pt>
                  <c:pt idx="30">
                    <c:v>3.9118480393918268E-4</c:v>
                  </c:pt>
                  <c:pt idx="31">
                    <c:v>1.5756960026769532E-3</c:v>
                  </c:pt>
                  <c:pt idx="32">
                    <c:v>7.8901864935404108E-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air-graph'!$I$3:$I$35</c:f>
              <c:strCache>
                <c:ptCount val="33"/>
                <c:pt idx="0">
                  <c:v>K02014; iron complex outermembrane recepter protein</c:v>
                </c:pt>
                <c:pt idx="1">
                  <c:v>K06147; ATP-binding cassette, subfamily B, bacterial</c:v>
                </c:pt>
                <c:pt idx="2">
                  <c:v>K03406; methyl-accepting chemotaxis protein</c:v>
                </c:pt>
                <c:pt idx="3">
                  <c:v>K03296; hydrophobic/amphiphilic exporter-1 (mainly G- bacteria), HAE1 family</c:v>
                </c:pt>
                <c:pt idx="4">
                  <c:v>K02004; putative ABC transport system permease protein</c:v>
                </c:pt>
                <c:pt idx="5">
                  <c:v>K08300; ribonuclease E [EC:3.1.26.12]</c:v>
                </c:pt>
                <c:pt idx="6">
                  <c:v>K07497; putative transposase</c:v>
                </c:pt>
                <c:pt idx="7">
                  <c:v>K00059; 3-oxoacyl-[acyl-carrier protein] reductase [EC:1.1.1.100]</c:v>
                </c:pt>
                <c:pt idx="8">
                  <c:v>K02035; peptide/nickel transport system substrate-binding protein</c:v>
                </c:pt>
                <c:pt idx="9">
                  <c:v>K02519; translation initiation factor IF-2</c:v>
                </c:pt>
                <c:pt idx="10">
                  <c:v>K03701; excinuclease ABC subunit A</c:v>
                </c:pt>
                <c:pt idx="11">
                  <c:v>K00936; [EC:2.7.3.-]</c:v>
                </c:pt>
                <c:pt idx="12">
                  <c:v>K01999; branched-chain amino acid transport system substrate-binding protein</c:v>
                </c:pt>
                <c:pt idx="13">
                  <c:v>K03088; RNA polymerase sigma-70 factor, ECF subfamily</c:v>
                </c:pt>
                <c:pt idx="14">
                  <c:v>K03046; DNA-directed RNA polymerase subunit beta' [EC:2.7.7.6]</c:v>
                </c:pt>
                <c:pt idx="15">
                  <c:v>K03657; DNA helicase II / ATP-dependent DNA helicase PcrA [EC:3.6.4.12]</c:v>
                </c:pt>
                <c:pt idx="16">
                  <c:v>K01955; carbamoyl-phosphate synthase large subunit [EC:6.3.5.5]</c:v>
                </c:pt>
                <c:pt idx="17">
                  <c:v>K03043; DNA-directed RNA polymerase subunit beta [EC:2.7.7.6]</c:v>
                </c:pt>
                <c:pt idx="18">
                  <c:v>K01533; Cu2+-exporting ATPase [EC:3.6.3.4]</c:v>
                </c:pt>
                <c:pt idx="19">
                  <c:v>K03466; DNA segregation ATPase FtsK/SpoIIIE, S-DNA-T family</c:v>
                </c:pt>
                <c:pt idx="20">
                  <c:v>K01952; phosphoribosylformylglycinamidine synthase [EC:6.3.5.3]</c:v>
                </c:pt>
                <c:pt idx="21">
                  <c:v>K02337; DNA polymerase III subunit alpha [EC:2.7.7.7]</c:v>
                </c:pt>
                <c:pt idx="22">
                  <c:v>K00540; [EC:1.-.-.-]</c:v>
                </c:pt>
                <c:pt idx="23">
                  <c:v>K01652; acetolactate synthase I/II/III large subunit [EC:2.2.1.6]</c:v>
                </c:pt>
                <c:pt idx="24">
                  <c:v>K02529; LacI family transcriptional regulator</c:v>
                </c:pt>
                <c:pt idx="25">
                  <c:v>K01190; beta-galactosidase [EC:3.2.1.23]</c:v>
                </c:pt>
                <c:pt idx="26">
                  <c:v>K01153; type I restriction enzyme, R subunit [EC:3.1.21.3]</c:v>
                </c:pt>
                <c:pt idx="27">
                  <c:v>K02355; elongation factor G</c:v>
                </c:pt>
                <c:pt idx="28">
                  <c:v>K02003; putative ABC transport system ATP-binding protein</c:v>
                </c:pt>
                <c:pt idx="29">
                  <c:v>K01915; glutamine synthetase [EC:6.3.1.2]</c:v>
                </c:pt>
                <c:pt idx="30">
                  <c:v>K02469; DNA gyrase subunit A [EC:5.99.1.3]</c:v>
                </c:pt>
                <c:pt idx="31">
                  <c:v>K05349; beta-glucosidase [EC:3.2.1.21]</c:v>
                </c:pt>
                <c:pt idx="32">
                  <c:v>K00257; [EC:1.3.99.-]</c:v>
                </c:pt>
              </c:strCache>
            </c:strRef>
          </c:cat>
          <c:val>
            <c:numRef>
              <c:f>'air-graph'!$K$3:$K$35</c:f>
              <c:numCache>
                <c:formatCode>General</c:formatCode>
                <c:ptCount val="33"/>
                <c:pt idx="0">
                  <c:v>6.7762272312292798E-3</c:v>
                </c:pt>
                <c:pt idx="1">
                  <c:v>6.5342504285094433E-3</c:v>
                </c:pt>
                <c:pt idx="2">
                  <c:v>4.6045116430027096E-3</c:v>
                </c:pt>
                <c:pt idx="3">
                  <c:v>4.9264290498253552E-3</c:v>
                </c:pt>
                <c:pt idx="4">
                  <c:v>4.8757301655967533E-3</c:v>
                </c:pt>
                <c:pt idx="5">
                  <c:v>2.5236101166520833E-3</c:v>
                </c:pt>
                <c:pt idx="6">
                  <c:v>2.4574859496629274E-3</c:v>
                </c:pt>
                <c:pt idx="7">
                  <c:v>2.3430611573102217E-3</c:v>
                </c:pt>
                <c:pt idx="8">
                  <c:v>2.6316809635676414E-3</c:v>
                </c:pt>
                <c:pt idx="9">
                  <c:v>2.4818433393947611E-3</c:v>
                </c:pt>
                <c:pt idx="10">
                  <c:v>2.9846393349277434E-3</c:v>
                </c:pt>
                <c:pt idx="11">
                  <c:v>2.3485457197103491E-3</c:v>
                </c:pt>
                <c:pt idx="12">
                  <c:v>1.7247237112442094E-3</c:v>
                </c:pt>
                <c:pt idx="13">
                  <c:v>2.7107924273679085E-3</c:v>
                </c:pt>
                <c:pt idx="14">
                  <c:v>2.5816333645389505E-3</c:v>
                </c:pt>
                <c:pt idx="15">
                  <c:v>2.6769798236066255E-3</c:v>
                </c:pt>
                <c:pt idx="16">
                  <c:v>2.7356905238432941E-3</c:v>
                </c:pt>
                <c:pt idx="17">
                  <c:v>2.4373144297534931E-3</c:v>
                </c:pt>
                <c:pt idx="18">
                  <c:v>2.1305418772088001E-3</c:v>
                </c:pt>
                <c:pt idx="19">
                  <c:v>2.1513026168666887E-3</c:v>
                </c:pt>
                <c:pt idx="20">
                  <c:v>2.1995206964569593E-3</c:v>
                </c:pt>
                <c:pt idx="21">
                  <c:v>2.2632152705533998E-3</c:v>
                </c:pt>
                <c:pt idx="22">
                  <c:v>1.682047985527948E-3</c:v>
                </c:pt>
                <c:pt idx="23">
                  <c:v>1.8890384902215307E-3</c:v>
                </c:pt>
                <c:pt idx="24">
                  <c:v>2.2233408804170837E-3</c:v>
                </c:pt>
                <c:pt idx="25">
                  <c:v>3.1088153661941089E-3</c:v>
                </c:pt>
                <c:pt idx="26">
                  <c:v>2.2158497142602206E-3</c:v>
                </c:pt>
                <c:pt idx="27">
                  <c:v>2.0830286272540085E-3</c:v>
                </c:pt>
                <c:pt idx="28">
                  <c:v>2.2739274970575169E-3</c:v>
                </c:pt>
                <c:pt idx="29">
                  <c:v>2.0974532505426968E-3</c:v>
                </c:pt>
                <c:pt idx="30">
                  <c:v>2.0051044166732486E-3</c:v>
                </c:pt>
                <c:pt idx="31">
                  <c:v>2.4929703540497242E-3</c:v>
                </c:pt>
                <c:pt idx="32">
                  <c:v>1.2042881418001525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CB2-4C3F-ACC7-19CC74DF07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605901328"/>
        <c:axId val="605904608"/>
      </c:barChart>
      <c:catAx>
        <c:axId val="60590132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605904608"/>
        <c:crosses val="autoZero"/>
        <c:auto val="1"/>
        <c:lblAlgn val="ctr"/>
        <c:lblOffset val="100"/>
        <c:noMultiLvlLbl val="0"/>
      </c:catAx>
      <c:valAx>
        <c:axId val="60590460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ko-KR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abundance</a:t>
                </a:r>
                <a:endParaRPr lang="ko-KR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 alt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605901328"/>
        <c:crosses val="autoZero"/>
        <c:crossBetween val="between"/>
        <c:majorUnit val="2.0000000000000005E-3"/>
      </c:valAx>
      <c:spPr>
        <a:noFill/>
        <a:ln>
          <a:noFill/>
        </a:ln>
        <a:effectLst/>
      </c:spPr>
    </c:plotArea>
    <c:legend>
      <c:legendPos val="tr"/>
      <c:layout>
        <c:manualLayout>
          <c:xMode val="edge"/>
          <c:yMode val="edge"/>
          <c:x val="0.86277109981099576"/>
          <c:y val="1.8289894833104711E-2"/>
          <c:w val="9.4728948069080998E-2"/>
          <c:h val="4.3438932273383517E-2"/>
        </c:manualLayout>
      </c:layout>
      <c:overlay val="1"/>
      <c:spPr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dk1"/>
              </a:solidFill>
              <a:latin typeface="+mn-lt"/>
              <a:ea typeface="+mn-ea"/>
              <a:cs typeface="+mn-cs"/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'soil-graph'!$J$2</c:f>
              <c:strCache>
                <c:ptCount val="1"/>
                <c:pt idx="0">
                  <c:v>SB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oil-graph'!$M$3:$M$29</c:f>
                <c:numCache>
                  <c:formatCode>General</c:formatCode>
                  <c:ptCount val="27"/>
                  <c:pt idx="0">
                    <c:v>1.1250388631969166E-3</c:v>
                  </c:pt>
                  <c:pt idx="1">
                    <c:v>1.0998606120921062E-3</c:v>
                  </c:pt>
                  <c:pt idx="2">
                    <c:v>6.5422250118787699E-4</c:v>
                  </c:pt>
                  <c:pt idx="3">
                    <c:v>8.7771171076309344E-4</c:v>
                  </c:pt>
                  <c:pt idx="4">
                    <c:v>9.5722051214510698E-4</c:v>
                  </c:pt>
                  <c:pt idx="5">
                    <c:v>9.2414659629984027E-4</c:v>
                  </c:pt>
                  <c:pt idx="6">
                    <c:v>8.6197090098420845E-4</c:v>
                  </c:pt>
                  <c:pt idx="7">
                    <c:v>8.5843521329200499E-4</c:v>
                  </c:pt>
                  <c:pt idx="8">
                    <c:v>4.3369614761609618E-4</c:v>
                  </c:pt>
                  <c:pt idx="9">
                    <c:v>3.2402599631189494E-4</c:v>
                  </c:pt>
                  <c:pt idx="10">
                    <c:v>1.522710001953749E-3</c:v>
                  </c:pt>
                  <c:pt idx="11">
                    <c:v>3.2633562069415956E-4</c:v>
                  </c:pt>
                  <c:pt idx="12">
                    <c:v>8.9777558483142598E-4</c:v>
                  </c:pt>
                  <c:pt idx="13">
                    <c:v>6.568884604958062E-4</c:v>
                  </c:pt>
                  <c:pt idx="14">
                    <c:v>6.0518873814299648E-4</c:v>
                  </c:pt>
                  <c:pt idx="15">
                    <c:v>1.1652431756795441E-3</c:v>
                  </c:pt>
                  <c:pt idx="16">
                    <c:v>5.1085908691284054E-4</c:v>
                  </c:pt>
                  <c:pt idx="17">
                    <c:v>8.7836156166602296E-4</c:v>
                  </c:pt>
                  <c:pt idx="18">
                    <c:v>1.0070647104675761E-3</c:v>
                  </c:pt>
                  <c:pt idx="19">
                    <c:v>4.8627751314238982E-4</c:v>
                  </c:pt>
                  <c:pt idx="20">
                    <c:v>5.1935651162064137E-4</c:v>
                  </c:pt>
                  <c:pt idx="21">
                    <c:v>8.0744457537577105E-4</c:v>
                  </c:pt>
                  <c:pt idx="22">
                    <c:v>5.9342762312184947E-4</c:v>
                  </c:pt>
                  <c:pt idx="23">
                    <c:v>6.9087491828886212E-4</c:v>
                  </c:pt>
                  <c:pt idx="24">
                    <c:v>2.9603999500977412E-4</c:v>
                  </c:pt>
                  <c:pt idx="25">
                    <c:v>5.9170335266897026E-4</c:v>
                  </c:pt>
                  <c:pt idx="26">
                    <c:v>3.5623387400743301E-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oil-graph'!$I$3:$I$29</c:f>
              <c:strCache>
                <c:ptCount val="27"/>
                <c:pt idx="0">
                  <c:v>K00059; 3-oxoacyl-[acyl-carrier protein] reductase [EC:1.1.1.100]</c:v>
                </c:pt>
                <c:pt idx="1">
                  <c:v>K02031; peptide/nickel transport system ATP-binding protein</c:v>
                </c:pt>
                <c:pt idx="2">
                  <c:v>K02003; putative ABC transport system ATP-binding protein</c:v>
                </c:pt>
                <c:pt idx="3">
                  <c:v>K02032; peptide/nickel transport system ATP-binding protein</c:v>
                </c:pt>
                <c:pt idx="4">
                  <c:v>K01990; ABC-2 type transport system ATP-binding protein</c:v>
                </c:pt>
                <c:pt idx="5">
                  <c:v>K02049; NitT/TauT family transport system ATP-binding protein</c:v>
                </c:pt>
                <c:pt idx="6">
                  <c:v>K02028; polar amino acid transport system ATP-binding protein [EC:3.6.3.21]</c:v>
                </c:pt>
                <c:pt idx="7">
                  <c:v>K03088; RNA polymerase sigma-70 factor, ECF subfamily</c:v>
                </c:pt>
                <c:pt idx="8">
                  <c:v>K06147; ATP-binding cassette, subfamily B, bacterial</c:v>
                </c:pt>
                <c:pt idx="9">
                  <c:v>K02483; two-component system, OmpR family, response regulator</c:v>
                </c:pt>
                <c:pt idx="10">
                  <c:v>K02014; iron complex outermembrane recepter protein</c:v>
                </c:pt>
                <c:pt idx="11">
                  <c:v>K02013; iron complex transport system ATP-binding protein [EC:3.6.3.34]</c:v>
                </c:pt>
                <c:pt idx="12">
                  <c:v>K02529; LacI family transcriptional regulator</c:v>
                </c:pt>
                <c:pt idx="13">
                  <c:v>K07497; putative transposase</c:v>
                </c:pt>
                <c:pt idx="14">
                  <c:v>K02010; iron(III) transport system ATP-binding protein [EC:3.6.3.30]</c:v>
                </c:pt>
                <c:pt idx="15">
                  <c:v>K03406; methyl-accepting chemotaxis protein</c:v>
                </c:pt>
                <c:pt idx="16">
                  <c:v>K02052; putative spermidine/putrescine transport system ATP-binding protein</c:v>
                </c:pt>
                <c:pt idx="17">
                  <c:v>K01995; branched-chain amino acid transport system ATP-binding protein</c:v>
                </c:pt>
                <c:pt idx="18">
                  <c:v>K02029; polar amino acid transport system permease protein</c:v>
                </c:pt>
                <c:pt idx="19">
                  <c:v>K10112; multiple sugar transport system ATP-binding protein</c:v>
                </c:pt>
                <c:pt idx="20">
                  <c:v>K21023; diguanylate cyclase [EC:2.7.7.65]</c:v>
                </c:pt>
                <c:pt idx="21">
                  <c:v>K03566; LysR family transcriptional regulator, glycine cleavage system transcriptional activator</c:v>
                </c:pt>
                <c:pt idx="22">
                  <c:v>K21405; sigma-54 dependent transcriptional regulator, acetoin dehydrogenase operon transcriptional activator AcoR</c:v>
                </c:pt>
                <c:pt idx="23">
                  <c:v>K01996; branched-chain amino acid transport system ATP-binding protein</c:v>
                </c:pt>
                <c:pt idx="24">
                  <c:v>K00128; aldehyde dehydrogenase (NAD+) [EC:1.2.1.3]</c:v>
                </c:pt>
                <c:pt idx="25">
                  <c:v>K00249; acyl-CoA dehydrogenase [EC:1.3.8.7]</c:v>
                </c:pt>
                <c:pt idx="26">
                  <c:v>K07483; transposase</c:v>
                </c:pt>
              </c:strCache>
            </c:strRef>
          </c:cat>
          <c:val>
            <c:numRef>
              <c:f>'soil-graph'!$J$3:$J$29</c:f>
              <c:numCache>
                <c:formatCode>General</c:formatCode>
                <c:ptCount val="27"/>
                <c:pt idx="0">
                  <c:v>7.767991121772227E-3</c:v>
                </c:pt>
                <c:pt idx="1">
                  <c:v>5.2600006717965159E-3</c:v>
                </c:pt>
                <c:pt idx="2">
                  <c:v>5.2186927787296862E-3</c:v>
                </c:pt>
                <c:pt idx="3">
                  <c:v>4.6770732554322876E-3</c:v>
                </c:pt>
                <c:pt idx="4">
                  <c:v>4.1863974668318411E-3</c:v>
                </c:pt>
                <c:pt idx="5">
                  <c:v>4.0832150609894516E-3</c:v>
                </c:pt>
                <c:pt idx="6">
                  <c:v>3.2825105902550907E-3</c:v>
                </c:pt>
                <c:pt idx="7">
                  <c:v>4.2265761726831847E-3</c:v>
                </c:pt>
                <c:pt idx="8">
                  <c:v>2.5524680615249787E-3</c:v>
                </c:pt>
                <c:pt idx="9">
                  <c:v>3.2327196071996562E-3</c:v>
                </c:pt>
                <c:pt idx="10">
                  <c:v>3.7280960198507822E-3</c:v>
                </c:pt>
                <c:pt idx="11">
                  <c:v>2.5843654956501996E-3</c:v>
                </c:pt>
                <c:pt idx="12">
                  <c:v>2.2862653270243182E-3</c:v>
                </c:pt>
                <c:pt idx="13">
                  <c:v>1.8823724412891224E-3</c:v>
                </c:pt>
                <c:pt idx="14">
                  <c:v>2.714829603657677E-3</c:v>
                </c:pt>
                <c:pt idx="15">
                  <c:v>2.9287657519984165E-3</c:v>
                </c:pt>
                <c:pt idx="16">
                  <c:v>2.3028589892441927E-3</c:v>
                </c:pt>
                <c:pt idx="17">
                  <c:v>2.6259908069206071E-3</c:v>
                </c:pt>
                <c:pt idx="18">
                  <c:v>2.204332007342089E-3</c:v>
                </c:pt>
                <c:pt idx="19">
                  <c:v>2.0984429594211027E-3</c:v>
                </c:pt>
                <c:pt idx="20">
                  <c:v>2.325268172159653E-3</c:v>
                </c:pt>
                <c:pt idx="21">
                  <c:v>2.2007426575166257E-3</c:v>
                </c:pt>
                <c:pt idx="22">
                  <c:v>2.1410540071422103E-3</c:v>
                </c:pt>
                <c:pt idx="23">
                  <c:v>2.0934650522670857E-3</c:v>
                </c:pt>
                <c:pt idx="24">
                  <c:v>2.0787299306911349E-3</c:v>
                </c:pt>
                <c:pt idx="25">
                  <c:v>2.2084531358387612E-3</c:v>
                </c:pt>
                <c:pt idx="26">
                  <c:v>7.6559127150939335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78E-42CE-83C4-509F48867F7F}"/>
            </c:ext>
          </c:extLst>
        </c:ser>
        <c:ser>
          <c:idx val="1"/>
          <c:order val="1"/>
          <c:tx>
            <c:strRef>
              <c:f>'soil-graph'!$K$2</c:f>
              <c:strCache>
                <c:ptCount val="1"/>
                <c:pt idx="0">
                  <c:v>SE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oil-graph'!$N$3:$N$29</c:f>
                <c:numCache>
                  <c:formatCode>General</c:formatCode>
                  <c:ptCount val="27"/>
                  <c:pt idx="0">
                    <c:v>1.8312216017639003E-3</c:v>
                  </c:pt>
                  <c:pt idx="1">
                    <c:v>7.9956511965300248E-4</c:v>
                  </c:pt>
                  <c:pt idx="2">
                    <c:v>3.8826334719971046E-4</c:v>
                  </c:pt>
                  <c:pt idx="3">
                    <c:v>4.6801287542086543E-4</c:v>
                  </c:pt>
                  <c:pt idx="4">
                    <c:v>5.9309274920526145E-4</c:v>
                  </c:pt>
                  <c:pt idx="5">
                    <c:v>6.1153721952559247E-4</c:v>
                  </c:pt>
                  <c:pt idx="6">
                    <c:v>4.6680601274819779E-4</c:v>
                  </c:pt>
                  <c:pt idx="7">
                    <c:v>1.0089200156297004E-3</c:v>
                  </c:pt>
                  <c:pt idx="8">
                    <c:v>3.8833431390146857E-4</c:v>
                  </c:pt>
                  <c:pt idx="9">
                    <c:v>4.4343523665709827E-4</c:v>
                  </c:pt>
                  <c:pt idx="10">
                    <c:v>6.3631683409551916E-4</c:v>
                  </c:pt>
                  <c:pt idx="11">
                    <c:v>2.7879884965931488E-4</c:v>
                  </c:pt>
                  <c:pt idx="12">
                    <c:v>8.4727734569190177E-4</c:v>
                  </c:pt>
                  <c:pt idx="13">
                    <c:v>6.3810519946650671E-4</c:v>
                  </c:pt>
                  <c:pt idx="14">
                    <c:v>6.044270224389726E-4</c:v>
                  </c:pt>
                  <c:pt idx="15">
                    <c:v>9.4220037901895253E-4</c:v>
                  </c:pt>
                  <c:pt idx="16">
                    <c:v>3.2415629443118606E-4</c:v>
                  </c:pt>
                  <c:pt idx="17">
                    <c:v>3.7591204928716192E-4</c:v>
                  </c:pt>
                  <c:pt idx="18">
                    <c:v>5.9018525305103348E-4</c:v>
                  </c:pt>
                  <c:pt idx="19">
                    <c:v>3.1774060177131366E-4</c:v>
                  </c:pt>
                  <c:pt idx="20">
                    <c:v>4.9114069265697013E-4</c:v>
                  </c:pt>
                  <c:pt idx="21">
                    <c:v>6.2099941555975513E-4</c:v>
                  </c:pt>
                  <c:pt idx="22">
                    <c:v>3.9046431507631051E-4</c:v>
                  </c:pt>
                  <c:pt idx="23">
                    <c:v>4.9511089111847382E-4</c:v>
                  </c:pt>
                  <c:pt idx="24">
                    <c:v>6.5426205844074429E-4</c:v>
                  </c:pt>
                  <c:pt idx="25">
                    <c:v>6.1230787851278951E-4</c:v>
                  </c:pt>
                  <c:pt idx="26">
                    <c:v>8.0711454094802579E-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oil-graph'!$I$3:$I$29</c:f>
              <c:strCache>
                <c:ptCount val="27"/>
                <c:pt idx="0">
                  <c:v>K00059; 3-oxoacyl-[acyl-carrier protein] reductase [EC:1.1.1.100]</c:v>
                </c:pt>
                <c:pt idx="1">
                  <c:v>K02031; peptide/nickel transport system ATP-binding protein</c:v>
                </c:pt>
                <c:pt idx="2">
                  <c:v>K02003; putative ABC transport system ATP-binding protein</c:v>
                </c:pt>
                <c:pt idx="3">
                  <c:v>K02032; peptide/nickel transport system ATP-binding protein</c:v>
                </c:pt>
                <c:pt idx="4">
                  <c:v>K01990; ABC-2 type transport system ATP-binding protein</c:v>
                </c:pt>
                <c:pt idx="5">
                  <c:v>K02049; NitT/TauT family transport system ATP-binding protein</c:v>
                </c:pt>
                <c:pt idx="6">
                  <c:v>K02028; polar amino acid transport system ATP-binding protein [EC:3.6.3.21]</c:v>
                </c:pt>
                <c:pt idx="7">
                  <c:v>K03088; RNA polymerase sigma-70 factor, ECF subfamily</c:v>
                </c:pt>
                <c:pt idx="8">
                  <c:v>K06147; ATP-binding cassette, subfamily B, bacterial</c:v>
                </c:pt>
                <c:pt idx="9">
                  <c:v>K02483; two-component system, OmpR family, response regulator</c:v>
                </c:pt>
                <c:pt idx="10">
                  <c:v>K02014; iron complex outermembrane recepter protein</c:v>
                </c:pt>
                <c:pt idx="11">
                  <c:v>K02013; iron complex transport system ATP-binding protein [EC:3.6.3.34]</c:v>
                </c:pt>
                <c:pt idx="12">
                  <c:v>K02529; LacI family transcriptional regulator</c:v>
                </c:pt>
                <c:pt idx="13">
                  <c:v>K07497; putative transposase</c:v>
                </c:pt>
                <c:pt idx="14">
                  <c:v>K02010; iron(III) transport system ATP-binding protein [EC:3.6.3.30]</c:v>
                </c:pt>
                <c:pt idx="15">
                  <c:v>K03406; methyl-accepting chemotaxis protein</c:v>
                </c:pt>
                <c:pt idx="16">
                  <c:v>K02052; putative spermidine/putrescine transport system ATP-binding protein</c:v>
                </c:pt>
                <c:pt idx="17">
                  <c:v>K01995; branched-chain amino acid transport system ATP-binding protein</c:v>
                </c:pt>
                <c:pt idx="18">
                  <c:v>K02029; polar amino acid transport system permease protein</c:v>
                </c:pt>
                <c:pt idx="19">
                  <c:v>K10112; multiple sugar transport system ATP-binding protein</c:v>
                </c:pt>
                <c:pt idx="20">
                  <c:v>K21023; diguanylate cyclase [EC:2.7.7.65]</c:v>
                </c:pt>
                <c:pt idx="21">
                  <c:v>K03566; LysR family transcriptional regulator, glycine cleavage system transcriptional activator</c:v>
                </c:pt>
                <c:pt idx="22">
                  <c:v>K21405; sigma-54 dependent transcriptional regulator, acetoin dehydrogenase operon transcriptional activator AcoR</c:v>
                </c:pt>
                <c:pt idx="23">
                  <c:v>K01996; branched-chain amino acid transport system ATP-binding protein</c:v>
                </c:pt>
                <c:pt idx="24">
                  <c:v>K00128; aldehyde dehydrogenase (NAD+) [EC:1.2.1.3]</c:v>
                </c:pt>
                <c:pt idx="25">
                  <c:v>K00249; acyl-CoA dehydrogenase [EC:1.3.8.7]</c:v>
                </c:pt>
                <c:pt idx="26">
                  <c:v>K07483; transposase</c:v>
                </c:pt>
              </c:strCache>
            </c:strRef>
          </c:cat>
          <c:val>
            <c:numRef>
              <c:f>'soil-graph'!$K$3:$K$29</c:f>
              <c:numCache>
                <c:formatCode>General</c:formatCode>
                <c:ptCount val="27"/>
                <c:pt idx="0">
                  <c:v>4.3274291430444173E-3</c:v>
                </c:pt>
                <c:pt idx="1">
                  <c:v>5.3911201148810354E-3</c:v>
                </c:pt>
                <c:pt idx="2">
                  <c:v>5.303910867106674E-3</c:v>
                </c:pt>
                <c:pt idx="3">
                  <c:v>5.1244981873529594E-3</c:v>
                </c:pt>
                <c:pt idx="4">
                  <c:v>4.1882661925450185E-3</c:v>
                </c:pt>
                <c:pt idx="5">
                  <c:v>3.3573715638544441E-3</c:v>
                </c:pt>
                <c:pt idx="6">
                  <c:v>3.3481886750687025E-3</c:v>
                </c:pt>
                <c:pt idx="7">
                  <c:v>2.0726407623433201E-3</c:v>
                </c:pt>
                <c:pt idx="8">
                  <c:v>3.3784637568253207E-3</c:v>
                </c:pt>
                <c:pt idx="9">
                  <c:v>2.6307428845206318E-3</c:v>
                </c:pt>
                <c:pt idx="10">
                  <c:v>1.793708360533822E-3</c:v>
                </c:pt>
                <c:pt idx="11">
                  <c:v>2.8607138164645747E-3</c:v>
                </c:pt>
                <c:pt idx="12">
                  <c:v>2.8390117378414869E-3</c:v>
                </c:pt>
                <c:pt idx="13">
                  <c:v>3.1310169743638803E-3</c:v>
                </c:pt>
                <c:pt idx="14">
                  <c:v>2.2723123638866195E-3</c:v>
                </c:pt>
                <c:pt idx="15">
                  <c:v>1.8435946633205366E-3</c:v>
                </c:pt>
                <c:pt idx="16">
                  <c:v>2.2493327337795277E-3</c:v>
                </c:pt>
                <c:pt idx="17">
                  <c:v>1.8444712069219612E-3</c:v>
                </c:pt>
                <c:pt idx="18">
                  <c:v>2.2653172075959072E-3</c:v>
                </c:pt>
                <c:pt idx="19">
                  <c:v>2.2349069789739349E-3</c:v>
                </c:pt>
                <c:pt idx="20">
                  <c:v>1.4873658068940785E-3</c:v>
                </c:pt>
                <c:pt idx="21">
                  <c:v>1.5105019244909357E-3</c:v>
                </c:pt>
                <c:pt idx="22">
                  <c:v>1.4782962212539726E-3</c:v>
                </c:pt>
                <c:pt idx="23">
                  <c:v>1.4419273263636271E-3</c:v>
                </c:pt>
                <c:pt idx="24">
                  <c:v>1.4340478247035272E-3</c:v>
                </c:pt>
                <c:pt idx="25">
                  <c:v>1.0655635099711645E-3</c:v>
                </c:pt>
                <c:pt idx="26">
                  <c:v>2.2717493433161485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78E-42CE-83C4-509F48867F7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659830744"/>
        <c:axId val="659832056"/>
      </c:barChart>
      <c:catAx>
        <c:axId val="65983074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659832056"/>
        <c:crosses val="autoZero"/>
        <c:auto val="1"/>
        <c:lblAlgn val="ctr"/>
        <c:lblOffset val="100"/>
        <c:noMultiLvlLbl val="0"/>
      </c:catAx>
      <c:valAx>
        <c:axId val="659832056"/>
        <c:scaling>
          <c:orientation val="minMax"/>
          <c:max val="9.0000000000000028E-3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Relative abundance</a:t>
                </a:r>
                <a:endParaRPr lang="ko-KR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659830744"/>
        <c:crosses val="autoZero"/>
        <c:crossBetween val="between"/>
        <c:majorUnit val="3.0000000000000009E-3"/>
      </c:valAx>
      <c:spPr>
        <a:noFill/>
        <a:ln>
          <a:noFill/>
        </a:ln>
        <a:effectLst/>
      </c:spPr>
    </c:plotArea>
    <c:legend>
      <c:legendPos val="tr"/>
      <c:layout>
        <c:manualLayout>
          <c:xMode val="edge"/>
          <c:yMode val="edge"/>
          <c:x val="0.82721646219561917"/>
          <c:y val="2.9058393642847173E-2"/>
          <c:w val="0.11647383443585389"/>
          <c:h val="4.4146933741054335E-2"/>
        </c:manualLayout>
      </c:layout>
      <c:overlay val="1"/>
      <c:spPr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6539142-D700-994C-A881-2F83CBF1E36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D0B609C9-9D6F-3140-BACC-62342CD3997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D865CE8-A1B2-DF42-AD2C-FB6F504703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BC32C-69BB-D44F-9226-ECFD85FF2785}" type="datetimeFigureOut">
              <a:rPr kumimoji="1" lang="ko-KR" altLang="en-US" smtClean="0"/>
              <a:t>2025-03-02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315B027-D345-D348-83D0-A854B4BE03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B9A9FAF-4601-144B-9600-6526EC9425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D0A96-FE87-934B-8F74-128B0FB2BAD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24584918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C5D06C2-9250-184C-9C5C-6472C100B2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886A49DF-C4BD-6743-A64A-FC380EFCE1E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CDA8940-7D12-E349-AC1E-72F37505C4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BC32C-69BB-D44F-9226-ECFD85FF2785}" type="datetimeFigureOut">
              <a:rPr kumimoji="1" lang="ko-KR" altLang="en-US" smtClean="0"/>
              <a:t>2025-03-02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C316056-AD54-6640-ABFE-7557602F5E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6666D7E-DA06-0547-8E5D-6FC3908406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D0A96-FE87-934B-8F74-128B0FB2BAD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34685526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91154AFF-965C-D04A-88FF-D9A41ABA4A5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DC5C0C01-8AE4-D444-9FA1-FFA3E7867B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D9937DE-C0E8-6B4E-AC02-ED4B932162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BC32C-69BB-D44F-9226-ECFD85FF2785}" type="datetimeFigureOut">
              <a:rPr kumimoji="1" lang="ko-KR" altLang="en-US" smtClean="0"/>
              <a:t>2025-03-02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3B61F67-BB2D-6946-867B-D44EF4E27D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BE43365-4E8E-1044-92B3-B15C8A7DA3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D0A96-FE87-934B-8F74-128B0FB2BAD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22841625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6BB97C6-78BF-E54B-8D40-59A1C11EF2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6148553A-BB27-D148-B4D2-1F792CE0AC3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91E9F3A-68E9-6849-9AC7-B6069E22FC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BC32C-69BB-D44F-9226-ECFD85FF2785}" type="datetimeFigureOut">
              <a:rPr kumimoji="1" lang="ko-KR" altLang="en-US" smtClean="0"/>
              <a:t>2025-03-02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BCE0A25-AFF4-CB4A-98A6-2290D8EF33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FB920C9-1DD3-D24A-819F-BA63FBEF6E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D0A96-FE87-934B-8F74-128B0FB2BAD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7180209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E159F83-7F70-1748-9570-5D1052B9AD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56D916C-CA3B-1742-9693-2BFB545057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3D88949-F5E1-A545-B8AE-7BF7878654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BC32C-69BB-D44F-9226-ECFD85FF2785}" type="datetimeFigureOut">
              <a:rPr kumimoji="1" lang="ko-KR" altLang="en-US" smtClean="0"/>
              <a:t>2025-03-02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8A44757-11A7-1A46-933B-C3694D1C59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5E7D94A-BCBF-4840-BF78-28FD668713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D0A96-FE87-934B-8F74-128B0FB2BAD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9711680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F83F531-231D-F348-B7A6-985B7C3B3D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D6CBF89-2EA8-1647-9453-556E107FBDE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403A56D1-AC11-824E-A391-8262751284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D223AE85-2D0D-4247-8428-547FA632F9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BC32C-69BB-D44F-9226-ECFD85FF2785}" type="datetimeFigureOut">
              <a:rPr kumimoji="1" lang="ko-KR" altLang="en-US" smtClean="0"/>
              <a:t>2025-03-02</a:t>
            </a:fld>
            <a:endParaRPr kumimoji="1"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960AB0A-C9F7-D644-9061-9CFB060C63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262D5CF-5A7F-7D4A-8DD3-2D6D0AAB8A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D0A96-FE87-934B-8F74-128B0FB2BAD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32899827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B92C1DA-4F8A-5342-82FD-29AEBC031E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93EF963E-2603-A14D-9707-DA0AC93AAC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EE7F900F-E6DB-C94F-8E2C-AEA868BA16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A7E5A12B-E758-E84C-9641-A76C8DB0ED5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9C0BF3C1-4EFA-E545-968E-728953F4AAE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CBC5504D-5584-654E-AFAA-18131AC7A7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BC32C-69BB-D44F-9226-ECFD85FF2785}" type="datetimeFigureOut">
              <a:rPr kumimoji="1" lang="ko-KR" altLang="en-US" smtClean="0"/>
              <a:t>2025-03-02</a:t>
            </a:fld>
            <a:endParaRPr kumimoji="1"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8AB6A627-FEF4-DE4A-A440-DC28710661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1B0C552E-19F8-B04E-9CDF-AD1F3311B8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D0A96-FE87-934B-8F74-128B0FB2BAD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5699655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C459705-B599-934E-9F02-E1AA821C70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02DCA441-4676-514E-8F89-A6B9C3EE3F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BC32C-69BB-D44F-9226-ECFD85FF2785}" type="datetimeFigureOut">
              <a:rPr kumimoji="1" lang="ko-KR" altLang="en-US" smtClean="0"/>
              <a:t>2025-03-02</a:t>
            </a:fld>
            <a:endParaRPr kumimoji="1"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F95F6CA9-9BB0-1747-9110-3F581DBE8F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B3A64443-6611-B246-A8D8-8B92476D43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D0A96-FE87-934B-8F74-128B0FB2BAD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27891119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956D0FEF-2E36-2A46-8D68-58E3797008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BC32C-69BB-D44F-9226-ECFD85FF2785}" type="datetimeFigureOut">
              <a:rPr kumimoji="1" lang="ko-KR" altLang="en-US" smtClean="0"/>
              <a:t>2025-03-02</a:t>
            </a:fld>
            <a:endParaRPr kumimoji="1"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176BC647-70F1-104F-B788-58FB0F99FC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A1C3DD9C-BE60-DE41-B029-4490B6D2A7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D0A96-FE87-934B-8F74-128B0FB2BAD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34750203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AD2FB27-E315-DD4E-A103-F546837808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2DF5FFED-72AC-404D-9FAD-87724D3D997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804B7DFB-66DF-1147-8E65-7BD04672B9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F4F4AEB-A64F-244B-AE0A-3EAAB8D256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BC32C-69BB-D44F-9226-ECFD85FF2785}" type="datetimeFigureOut">
              <a:rPr kumimoji="1" lang="ko-KR" altLang="en-US" smtClean="0"/>
              <a:t>2025-03-02</a:t>
            </a:fld>
            <a:endParaRPr kumimoji="1"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6AD90FD-C620-8C4D-B133-A214B8E96E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6FDBBC8-4074-E746-BDB2-5DC2F4896A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D0A96-FE87-934B-8F74-128B0FB2BAD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28305522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7461495-79B6-754A-A07D-C9A6D59FFA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997B85C3-0AF1-CA41-AD3B-825701AF564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618ECEB2-DF23-254D-9F7A-BD523F1F22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5F91A2F-14FA-EA44-9117-D920CC6216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BC32C-69BB-D44F-9226-ECFD85FF2785}" type="datetimeFigureOut">
              <a:rPr kumimoji="1" lang="ko-KR" altLang="en-US" smtClean="0"/>
              <a:t>2025-03-02</a:t>
            </a:fld>
            <a:endParaRPr kumimoji="1"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3E453E77-61D8-4847-8C10-DA877E65EE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024122E-6917-F945-80EB-DBC72046E3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D0A96-FE87-934B-8F74-128B0FB2BAD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28210453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52EC5883-1BCA-9449-9A71-BC494581E4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274A446-969F-1442-A68B-9994802BEC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806424B-2689-B046-AED7-963338515A2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BBC32C-69BB-D44F-9226-ECFD85FF2785}" type="datetimeFigureOut">
              <a:rPr kumimoji="1" lang="ko-KR" altLang="en-US" smtClean="0"/>
              <a:t>2025-03-02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778031A-BBE8-F04A-9326-6838C22432A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C059A16-0816-924A-8FF7-09696FC1CC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2D0A96-FE87-934B-8F74-128B0FB2BAD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41217622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차트 3">
            <a:extLst>
              <a:ext uri="{FF2B5EF4-FFF2-40B4-BE49-F238E27FC236}">
                <a16:creationId xmlns:a16="http://schemas.microsoft.com/office/drawing/2014/main" id="{00000000-0008-0000-06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42992840"/>
              </p:ext>
            </p:extLst>
          </p:nvPr>
        </p:nvGraphicFramePr>
        <p:xfrm>
          <a:off x="276943" y="520158"/>
          <a:ext cx="10405711" cy="63378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D36442AD-FD5C-409F-B519-EA826162DDCE}"/>
              </a:ext>
            </a:extLst>
          </p:cNvPr>
          <p:cNvSpPr txBox="1"/>
          <p:nvPr/>
        </p:nvSpPr>
        <p:spPr>
          <a:xfrm>
            <a:off x="276942" y="243159"/>
            <a:ext cx="65418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b="1" dirty="0"/>
              <a:t>Fig. S2. Dominant orthologous groups of bacteria and BEVs in (A) air and (B) soil.</a:t>
            </a:r>
          </a:p>
        </p:txBody>
      </p:sp>
      <p:graphicFrame>
        <p:nvGraphicFramePr>
          <p:cNvPr id="8" name="표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68068815"/>
              </p:ext>
            </p:extLst>
          </p:nvPr>
        </p:nvGraphicFramePr>
        <p:xfrm>
          <a:off x="10515293" y="520166"/>
          <a:ext cx="766916" cy="58191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66916">
                  <a:extLst>
                    <a:ext uri="{9D8B030D-6E8A-4147-A177-3AD203B41FA5}">
                      <a16:colId xmlns:a16="http://schemas.microsoft.com/office/drawing/2014/main" val="1737752281"/>
                    </a:ext>
                  </a:extLst>
                </a:gridCol>
              </a:tblGrid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ko-KR" altLang="en-US" sz="9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2226863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83072202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53929134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5314035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14477103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87845483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40135045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36202703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02659828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42572675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81325077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68663485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6872981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07444028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9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57166131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32115659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46775745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35356372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82373522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5596429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5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7795774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889984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19210941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9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79032411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39869115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1945676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53522198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56478724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91911423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56262788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62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07095552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4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29864627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73410113"/>
                  </a:ext>
                </a:extLst>
              </a:tr>
              <a:tr h="1711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50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38941321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233AF777-4EA8-490A-8AB2-10C1969AA757}"/>
              </a:ext>
            </a:extLst>
          </p:cNvPr>
          <p:cNvSpPr txBox="1"/>
          <p:nvPr/>
        </p:nvSpPr>
        <p:spPr>
          <a:xfrm>
            <a:off x="213238" y="643268"/>
            <a:ext cx="5915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(A)</a:t>
            </a:r>
            <a:endParaRPr lang="ko-KR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1900618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차트 4">
            <a:extLst>
              <a:ext uri="{FF2B5EF4-FFF2-40B4-BE49-F238E27FC236}">
                <a16:creationId xmlns:a16="http://schemas.microsoft.com/office/drawing/2014/main" id="{00000000-0008-0000-07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24563025"/>
              </p:ext>
            </p:extLst>
          </p:nvPr>
        </p:nvGraphicFramePr>
        <p:xfrm>
          <a:off x="276942" y="716184"/>
          <a:ext cx="10076688" cy="60046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233AF777-4EA8-490A-8AB2-10C1969AA757}"/>
              </a:ext>
            </a:extLst>
          </p:cNvPr>
          <p:cNvSpPr txBox="1"/>
          <p:nvPr/>
        </p:nvSpPr>
        <p:spPr>
          <a:xfrm>
            <a:off x="213238" y="643268"/>
            <a:ext cx="5915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(B)</a:t>
            </a:r>
            <a:endParaRPr lang="ko-KR" altLang="en-US" sz="1400" b="1" dirty="0"/>
          </a:p>
        </p:txBody>
      </p:sp>
      <p:graphicFrame>
        <p:nvGraphicFramePr>
          <p:cNvPr id="9" name="표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91480220"/>
              </p:ext>
            </p:extLst>
          </p:nvPr>
        </p:nvGraphicFramePr>
        <p:xfrm>
          <a:off x="10131835" y="658356"/>
          <a:ext cx="766916" cy="5523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66916">
                  <a:extLst>
                    <a:ext uri="{9D8B030D-6E8A-4147-A177-3AD203B41FA5}">
                      <a16:colId xmlns:a16="http://schemas.microsoft.com/office/drawing/2014/main" val="1737752281"/>
                    </a:ext>
                  </a:extLst>
                </a:gridCol>
              </a:tblGrid>
              <a:tr h="1972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ko-KR" altLang="en-US" sz="9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2226863"/>
                  </a:ext>
                </a:extLst>
              </a:tr>
              <a:tr h="1972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83072202"/>
                  </a:ext>
                </a:extLst>
              </a:tr>
              <a:tr h="1972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53929134"/>
                  </a:ext>
                </a:extLst>
              </a:tr>
              <a:tr h="1972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5314035"/>
                  </a:ext>
                </a:extLst>
              </a:tr>
              <a:tr h="1972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14477103"/>
                  </a:ext>
                </a:extLst>
              </a:tr>
              <a:tr h="1972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87845483"/>
                  </a:ext>
                </a:extLst>
              </a:tr>
              <a:tr h="1972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40135045"/>
                  </a:ext>
                </a:extLst>
              </a:tr>
              <a:tr h="1972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36202703"/>
                  </a:ext>
                </a:extLst>
              </a:tr>
              <a:tr h="1972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02659828"/>
                  </a:ext>
                </a:extLst>
              </a:tr>
              <a:tr h="1972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54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42572675"/>
                  </a:ext>
                </a:extLst>
              </a:tr>
              <a:tr h="1972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81325077"/>
                  </a:ext>
                </a:extLst>
              </a:tr>
              <a:tr h="1972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18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68663485"/>
                  </a:ext>
                </a:extLst>
              </a:tr>
              <a:tr h="1972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6872981"/>
                  </a:ext>
                </a:extLst>
              </a:tr>
              <a:tr h="1972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5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07444028"/>
                  </a:ext>
                </a:extLst>
              </a:tr>
              <a:tr h="1972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57166131"/>
                  </a:ext>
                </a:extLst>
              </a:tr>
              <a:tr h="1972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32115659"/>
                  </a:ext>
                </a:extLst>
              </a:tr>
              <a:tr h="1972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46775745"/>
                  </a:ext>
                </a:extLst>
              </a:tr>
              <a:tr h="1972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35356372"/>
                  </a:ext>
                </a:extLst>
              </a:tr>
              <a:tr h="1972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82373522"/>
                  </a:ext>
                </a:extLst>
              </a:tr>
              <a:tr h="1972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5596429"/>
                  </a:ext>
                </a:extLst>
              </a:tr>
              <a:tr h="1972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7795774"/>
                  </a:ext>
                </a:extLst>
              </a:tr>
              <a:tr h="1972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08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889984"/>
                  </a:ext>
                </a:extLst>
              </a:tr>
              <a:tr h="1972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19210941"/>
                  </a:ext>
                </a:extLst>
              </a:tr>
              <a:tr h="1972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83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79032411"/>
                  </a:ext>
                </a:extLst>
              </a:tr>
              <a:tr h="1972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7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39869115"/>
                  </a:ext>
                </a:extLst>
              </a:tr>
              <a:tr h="1972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85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1945676"/>
                  </a:ext>
                </a:extLst>
              </a:tr>
              <a:tr h="1972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0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53522198"/>
                  </a:ext>
                </a:extLst>
              </a:tr>
              <a:tr h="1972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56478724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D7D7F450-B561-597F-E02A-32A23F21E316}"/>
              </a:ext>
            </a:extLst>
          </p:cNvPr>
          <p:cNvSpPr txBox="1"/>
          <p:nvPr/>
        </p:nvSpPr>
        <p:spPr>
          <a:xfrm>
            <a:off x="276942" y="243159"/>
            <a:ext cx="65418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b="1" dirty="0"/>
              <a:t>Fig. S2. Dominant orthologous groups of bacteria and BEVs in (A) air and (B) soil.</a:t>
            </a:r>
          </a:p>
        </p:txBody>
      </p:sp>
    </p:spTree>
    <p:extLst>
      <p:ext uri="{BB962C8B-B14F-4D97-AF65-F5344CB8AC3E}">
        <p14:creationId xmlns:p14="http://schemas.microsoft.com/office/powerpoint/2010/main" val="10608804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7</TotalTime>
  <Words>141</Words>
  <Application>Microsoft Office PowerPoint</Application>
  <PresentationFormat>와이드스크린</PresentationFormat>
  <Paragraphs>68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6" baseType="lpstr">
      <vt:lpstr>맑은 고딕</vt:lpstr>
      <vt:lpstr>Arial</vt:lpstr>
      <vt:lpstr>Times New Roman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Microsoft Office 사용자</dc:creator>
  <cp:lastModifiedBy>양진호/세명대</cp:lastModifiedBy>
  <cp:revision>57</cp:revision>
  <dcterms:created xsi:type="dcterms:W3CDTF">2020-02-11T12:28:03Z</dcterms:created>
  <dcterms:modified xsi:type="dcterms:W3CDTF">2025-03-02T05:14:22Z</dcterms:modified>
</cp:coreProperties>
</file>